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3667" autoAdjust="0"/>
    <p:restoredTop sz="94660"/>
  </p:normalViewPr>
  <p:slideViewPr>
    <p:cSldViewPr snapToGrid="0">
      <p:cViewPr>
        <p:scale>
          <a:sx n="98" d="100"/>
          <a:sy n="98" d="100"/>
        </p:scale>
        <p:origin x="2244" y="13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6D5C90-D2BE-4CA3-97D4-803385A515C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D4E13E1-9FBD-4EC6-AB98-4E55B669199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B83560-CD9E-4135-976D-FE3BB4F45B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098B3E-1A15-44BA-A18D-9562BA1FF674}" type="datetimeFigureOut">
              <a:rPr lang="en-GB" smtClean="0"/>
              <a:t>04/11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BA7423-88B8-467C-83AF-545C2C74C8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1B51F4-FFDD-4F08-AB97-DBA084364F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EEE0E9-AECE-4EEE-8D24-39208BB7CB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130681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DE36B2-9F18-4DE2-A06C-FD1F099189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137D3BC-9496-47CB-A688-70142768848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F01AC6-2586-46E8-8FB8-927A389817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098B3E-1A15-44BA-A18D-9562BA1FF674}" type="datetimeFigureOut">
              <a:rPr lang="en-GB" smtClean="0"/>
              <a:t>04/11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727C12-15A7-4C91-8475-004AFFCEDA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0CACA7-20E0-4BB0-B901-F6449F22FC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EEE0E9-AECE-4EEE-8D24-39208BB7CB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44329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9304D4D-0580-4C8D-8952-B957FFB3566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121D8A6-D38A-4503-8ACD-8A2343A895C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B36D53-6962-4C0F-ADF9-AE8E87E631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098B3E-1A15-44BA-A18D-9562BA1FF674}" type="datetimeFigureOut">
              <a:rPr lang="en-GB" smtClean="0"/>
              <a:t>04/11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B2792D-2B45-4C51-A843-0B8E0206E4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0E94048-AB1A-423E-B084-44807E737D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EEE0E9-AECE-4EEE-8D24-39208BB7CB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08557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900B0C-098C-4A76-9404-6333DA9E97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CC55998-E734-4347-AC02-F6061A2F8C4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5AD3C4-B8B1-4418-93E9-9E56928FF0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098B3E-1A15-44BA-A18D-9562BA1FF674}" type="datetimeFigureOut">
              <a:rPr lang="en-GB" smtClean="0"/>
              <a:t>04/11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0E882B-BF0E-4794-9BB7-653FFD5BA9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FD9BA9-622F-4064-90A8-35160ABAE9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EEE0E9-AECE-4EEE-8D24-39208BB7CB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00360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ADE11A-5FDF-4356-A631-BCB45DD8F4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D80D349-4065-42AE-9EFB-3A7C1C9569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80AC69-4BD9-4AFF-B30F-74BE3CD026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098B3E-1A15-44BA-A18D-9562BA1FF674}" type="datetimeFigureOut">
              <a:rPr lang="en-GB" smtClean="0"/>
              <a:t>04/11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625F32-1DA9-45D4-A4AB-86509DDFAA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FDAE63-983A-4BD7-8543-8FB73B47AE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EEE0E9-AECE-4EEE-8D24-39208BB7CB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774278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0F5172-5999-4F6C-B999-8C67EA5D2D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5543198-31C3-48AB-9832-B05F60BAF7E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D24A2DC-7166-471F-BD6A-6FA8B5B2C31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29B7BE0-DA35-4848-A3A3-F7243FD40A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098B3E-1A15-44BA-A18D-9562BA1FF674}" type="datetimeFigureOut">
              <a:rPr lang="en-GB" smtClean="0"/>
              <a:t>04/11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6D92AAA-486C-4C7C-99BB-7A30ED29A9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2E85495-323D-46F9-885E-EEA51327A4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EEE0E9-AECE-4EEE-8D24-39208BB7CB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03046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E93EDB-F223-498B-B98A-C036741476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1126F5C-4550-494A-8948-BBB0DF0774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B0CF97E-FA49-435D-9F70-406DE8DB8A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8A0832C-A41B-45E3-893F-978516817B2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C964E6C-1C1C-4EA6-A6F6-6E49579EE9A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F5946E1-BEF5-4C80-AFDE-7EB9E54E05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098B3E-1A15-44BA-A18D-9562BA1FF674}" type="datetimeFigureOut">
              <a:rPr lang="en-GB" smtClean="0"/>
              <a:t>04/11/2020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4667D3B-8063-474D-8FDC-F1CD81DC9A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C7D1140-5FD3-49A8-BECF-83980F6A41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EEE0E9-AECE-4EEE-8D24-39208BB7CB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63720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B12473-CA62-4198-A7B8-0FB93802F4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F213C9D-2C64-492F-9441-6E83E761C6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098B3E-1A15-44BA-A18D-9562BA1FF674}" type="datetimeFigureOut">
              <a:rPr lang="en-GB" smtClean="0"/>
              <a:t>04/11/2020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F58E7B8-8B21-48E6-AD7F-70E850C271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A68B7FA-CD3F-4007-B189-6D0617F74B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EEE0E9-AECE-4EEE-8D24-39208BB7CB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7643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FB64568-5CCC-47B3-8048-BEE75885C9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098B3E-1A15-44BA-A18D-9562BA1FF674}" type="datetimeFigureOut">
              <a:rPr lang="en-GB" smtClean="0"/>
              <a:t>04/11/2020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A20212B-0219-45B2-9384-5D3E8A2D58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1DD6490-9F0D-4017-8E73-91FBAD1004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EEE0E9-AECE-4EEE-8D24-39208BB7CB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57861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3BDA43-A6FB-47A6-A5B7-B6565E64B2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7D19319-CD8C-4A1F-8D64-871393454B7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20FF97E-A593-4655-9FA7-26C3FEC3865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275A53D-0C4F-469A-B476-D60BF94838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098B3E-1A15-44BA-A18D-9562BA1FF674}" type="datetimeFigureOut">
              <a:rPr lang="en-GB" smtClean="0"/>
              <a:t>04/11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7C6AABD-D70A-4305-A76E-087F7170D5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F2772B7-CFE5-4584-B030-F90E12C5A0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EEE0E9-AECE-4EEE-8D24-39208BB7CB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3894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C5A040-3CFB-4B40-988B-B7DE3AA456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6D352A1-8980-4CC1-A214-02E2FA2830F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C0EE301-5AC2-4739-B40A-2DA1354108D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C9E74E3-B80F-4176-930D-213DB5FD22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098B3E-1A15-44BA-A18D-9562BA1FF674}" type="datetimeFigureOut">
              <a:rPr lang="en-GB" smtClean="0"/>
              <a:t>04/11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9E37BE7-4481-4A46-AFB5-31156F9ED2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3B2E7F3-3144-498A-9966-01E9EDABA1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EEE0E9-AECE-4EEE-8D24-39208BB7CB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88870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E3CCA6F-1D8A-467F-8C48-803CA93711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C56A800-5135-445D-819C-909F1A77EC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980E46-10DD-4090-B498-FE729CE59FC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098B3E-1A15-44BA-A18D-9562BA1FF674}" type="datetimeFigureOut">
              <a:rPr lang="en-GB" smtClean="0"/>
              <a:t>04/11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DDBA07-3993-461E-9D75-838EF7F8DAB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984903-7611-4737-8BE5-D63A6247FCC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EEE0E9-AECE-4EEE-8D24-39208BB7CB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080813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tiff"/><Relationship Id="rId13" Type="http://schemas.openxmlformats.org/officeDocument/2006/relationships/image" Target="../media/image9.tiff"/><Relationship Id="rId18" Type="http://schemas.openxmlformats.org/officeDocument/2006/relationships/image" Target="../media/image12.png"/><Relationship Id="rId3" Type="http://schemas.openxmlformats.org/officeDocument/2006/relationships/image" Target="../media/image2.png"/><Relationship Id="rId21" Type="http://schemas.microsoft.com/office/2007/relationships/hdphoto" Target="../media/hdphoto7.wdp"/><Relationship Id="rId7" Type="http://schemas.microsoft.com/office/2007/relationships/hdphoto" Target="../media/hdphoto2.wdp"/><Relationship Id="rId12" Type="http://schemas.openxmlformats.org/officeDocument/2006/relationships/image" Target="../media/image8.tiff"/><Relationship Id="rId17" Type="http://schemas.microsoft.com/office/2007/relationships/hdphoto" Target="../media/hdphoto5.wdp"/><Relationship Id="rId2" Type="http://schemas.openxmlformats.org/officeDocument/2006/relationships/image" Target="../media/image1.jpg"/><Relationship Id="rId16" Type="http://schemas.openxmlformats.org/officeDocument/2006/relationships/image" Target="../media/image11.png"/><Relationship Id="rId20" Type="http://schemas.openxmlformats.org/officeDocument/2006/relationships/image" Target="../media/image13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7.tiff"/><Relationship Id="rId5" Type="http://schemas.openxmlformats.org/officeDocument/2006/relationships/image" Target="../media/image3.tiff"/><Relationship Id="rId15" Type="http://schemas.microsoft.com/office/2007/relationships/hdphoto" Target="../media/hdphoto4.wdp"/><Relationship Id="rId10" Type="http://schemas.microsoft.com/office/2007/relationships/hdphoto" Target="../media/hdphoto3.wdp"/><Relationship Id="rId19" Type="http://schemas.microsoft.com/office/2007/relationships/hdphoto" Target="../media/hdphoto6.wdp"/><Relationship Id="rId4" Type="http://schemas.microsoft.com/office/2007/relationships/hdphoto" Target="../media/hdphoto1.wdp"/><Relationship Id="rId9" Type="http://schemas.openxmlformats.org/officeDocument/2006/relationships/image" Target="../media/image6.png"/><Relationship Id="rId14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sitting, purple, curtain, table&#10;&#10;Description automatically generated">
            <a:extLst>
              <a:ext uri="{FF2B5EF4-FFF2-40B4-BE49-F238E27FC236}">
                <a16:creationId xmlns:a16="http://schemas.microsoft.com/office/drawing/2014/main" id="{F892669D-15E8-4E0F-A101-CE96EE39CA3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889" t="-1731" r="-4550" b="-1376"/>
          <a:stretch/>
        </p:blipFill>
        <p:spPr>
          <a:xfrm rot="5400000">
            <a:off x="496189" y="1313319"/>
            <a:ext cx="2765141" cy="353822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ADFE77D-4942-4713-8E6F-88ECAC00AF78}"/>
              </a:ext>
            </a:extLst>
          </p:cNvPr>
          <p:cNvSpPr txBox="1"/>
          <p:nvPr/>
        </p:nvSpPr>
        <p:spPr>
          <a:xfrm rot="16200000">
            <a:off x="467868" y="1444542"/>
            <a:ext cx="6381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Marker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0E8F317-BDF3-458E-82D7-C33E19B82219}"/>
              </a:ext>
            </a:extLst>
          </p:cNvPr>
          <p:cNvSpPr txBox="1"/>
          <p:nvPr/>
        </p:nvSpPr>
        <p:spPr>
          <a:xfrm rot="16200000">
            <a:off x="784879" y="1484553"/>
            <a:ext cx="5581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25% S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E88A501-EA5E-47CD-BB81-682D6D565CD7}"/>
              </a:ext>
            </a:extLst>
          </p:cNvPr>
          <p:cNvSpPr txBox="1"/>
          <p:nvPr/>
        </p:nvSpPr>
        <p:spPr>
          <a:xfrm rot="16200000">
            <a:off x="1024374" y="1484553"/>
            <a:ext cx="5581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50% S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F523B3D-BBF1-45C9-A692-6489FF6DF6A0}"/>
              </a:ext>
            </a:extLst>
          </p:cNvPr>
          <p:cNvSpPr txBox="1"/>
          <p:nvPr/>
        </p:nvSpPr>
        <p:spPr>
          <a:xfrm rot="16200000">
            <a:off x="1262100" y="1445280"/>
            <a:ext cx="6367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100% S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9C95C32-E339-4F6A-8B7D-A559B51D60A3}"/>
              </a:ext>
            </a:extLst>
          </p:cNvPr>
          <p:cNvSpPr txBox="1"/>
          <p:nvPr/>
        </p:nvSpPr>
        <p:spPr>
          <a:xfrm rot="16200000">
            <a:off x="1439879" y="1353909"/>
            <a:ext cx="8194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100% SQ1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BCDEF34-4635-4B97-94C7-2BE4C4421C28}"/>
              </a:ext>
            </a:extLst>
          </p:cNvPr>
          <p:cNvSpPr txBox="1"/>
          <p:nvPr/>
        </p:nvSpPr>
        <p:spPr>
          <a:xfrm rot="16200000">
            <a:off x="1754102" y="1408347"/>
            <a:ext cx="7105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100% ES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EBBB551-CEC4-41E1-89E4-25D763BA2C49}"/>
              </a:ext>
            </a:extLst>
          </p:cNvPr>
          <p:cNvSpPr txBox="1"/>
          <p:nvPr/>
        </p:nvSpPr>
        <p:spPr>
          <a:xfrm rot="16200000">
            <a:off x="2007221" y="1401197"/>
            <a:ext cx="7248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100% ER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00111DA-7ECD-4AF1-BBA9-F46EC7F3B7F7}"/>
              </a:ext>
            </a:extLst>
          </p:cNvPr>
          <p:cNvSpPr txBox="1"/>
          <p:nvPr/>
        </p:nvSpPr>
        <p:spPr>
          <a:xfrm rot="16200000">
            <a:off x="1850996" y="930619"/>
            <a:ext cx="15746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100% S 100</a:t>
            </a:r>
            <a:r>
              <a:rPr lang="en-GB" sz="1200" baseline="30000" dirty="0"/>
              <a:t>o</a:t>
            </a:r>
            <a:r>
              <a:rPr lang="en-GB" sz="1200" dirty="0"/>
              <a:t>C heating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4E3A11F-968B-43D5-A75C-52A512BEB0DF}"/>
              </a:ext>
            </a:extLst>
          </p:cNvPr>
          <p:cNvSpPr txBox="1"/>
          <p:nvPr/>
        </p:nvSpPr>
        <p:spPr>
          <a:xfrm rot="16200000">
            <a:off x="2159676" y="1038757"/>
            <a:ext cx="14434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100% S without DTT</a:t>
            </a:r>
          </a:p>
        </p:txBody>
      </p:sp>
      <p:pic>
        <p:nvPicPr>
          <p:cNvPr id="26" name="Picture 25" descr="A close up of a logo&#10;&#10;Description automatically generated">
            <a:extLst>
              <a:ext uri="{FF2B5EF4-FFF2-40B4-BE49-F238E27FC236}">
                <a16:creationId xmlns:a16="http://schemas.microsoft.com/office/drawing/2014/main" id="{EEF2787A-FE9C-4BD5-B5F4-F2CF7816D49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5756" t="61373" r="37844" b="32369"/>
          <a:stretch/>
        </p:blipFill>
        <p:spPr>
          <a:xfrm flipH="1">
            <a:off x="6269976" y="576544"/>
            <a:ext cx="2040294" cy="347125"/>
          </a:xfrm>
          <a:prstGeom prst="rect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61F1C62B-7490-4845-9409-843A7B8BA20A}"/>
              </a:ext>
            </a:extLst>
          </p:cNvPr>
          <p:cNvSpPr txBox="1"/>
          <p:nvPr/>
        </p:nvSpPr>
        <p:spPr>
          <a:xfrm>
            <a:off x="7002334" y="335109"/>
            <a:ext cx="5456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Lhca4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FB535B50-924D-4CF0-9474-3F8F5E4D6147}"/>
              </a:ext>
            </a:extLst>
          </p:cNvPr>
          <p:cNvSpPr/>
          <p:nvPr/>
        </p:nvSpPr>
        <p:spPr>
          <a:xfrm>
            <a:off x="2507676" y="232926"/>
            <a:ext cx="572217" cy="161707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solidFill>
                <a:srgbClr val="FF0000"/>
              </a:solidFill>
            </a:endParaRPr>
          </a:p>
        </p:txBody>
      </p:sp>
      <p:pic>
        <p:nvPicPr>
          <p:cNvPr id="31" name="Picture 30" descr="A close up of a logo&#10;&#10;Description automatically generated">
            <a:extLst>
              <a:ext uri="{FF2B5EF4-FFF2-40B4-BE49-F238E27FC236}">
                <a16:creationId xmlns:a16="http://schemas.microsoft.com/office/drawing/2014/main" id="{5FFA1AE3-7D24-43A5-B073-F46A5C27945F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668" t="54853" r="40791" b="39274"/>
          <a:stretch/>
        </p:blipFill>
        <p:spPr>
          <a:xfrm>
            <a:off x="8811312" y="576544"/>
            <a:ext cx="2040294" cy="347125"/>
          </a:xfrm>
          <a:prstGeom prst="rect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4AB40BD4-4915-4B9B-A346-58FFF4090B0B}"/>
              </a:ext>
            </a:extLst>
          </p:cNvPr>
          <p:cNvSpPr txBox="1"/>
          <p:nvPr/>
        </p:nvSpPr>
        <p:spPr>
          <a:xfrm>
            <a:off x="9585115" y="335108"/>
            <a:ext cx="5533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Lhcb2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2ACDB781-53FF-468D-A334-5ECBB7D1F692}"/>
              </a:ext>
            </a:extLst>
          </p:cNvPr>
          <p:cNvSpPr txBox="1"/>
          <p:nvPr/>
        </p:nvSpPr>
        <p:spPr>
          <a:xfrm>
            <a:off x="3087742" y="531184"/>
            <a:ext cx="1813140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50" dirty="0">
                <a:solidFill>
                  <a:srgbClr val="FF0000"/>
                </a:solidFill>
              </a:rPr>
              <a:t>These two lanes were not used for either transferring or quantification (If transferred on membrane) on membrane and further down-stream process of western blotting</a:t>
            </a:r>
          </a:p>
        </p:txBody>
      </p:sp>
      <p:pic>
        <p:nvPicPr>
          <p:cNvPr id="37" name="Picture 36" descr="A picture containing transport, aircraft, airplane, flying&#10;&#10;Description automatically generated">
            <a:extLst>
              <a:ext uri="{FF2B5EF4-FFF2-40B4-BE49-F238E27FC236}">
                <a16:creationId xmlns:a16="http://schemas.microsoft.com/office/drawing/2014/main" id="{85FB5322-28FD-40CC-9116-8B0359EE77B6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892" t="47007" r="45277" b="48342"/>
          <a:stretch/>
        </p:blipFill>
        <p:spPr>
          <a:xfrm>
            <a:off x="8844380" y="3213906"/>
            <a:ext cx="2049631" cy="328818"/>
          </a:xfrm>
          <a:prstGeom prst="rect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</p:pic>
      <p:sp>
        <p:nvSpPr>
          <p:cNvPr id="39" name="TextBox 38">
            <a:extLst>
              <a:ext uri="{FF2B5EF4-FFF2-40B4-BE49-F238E27FC236}">
                <a16:creationId xmlns:a16="http://schemas.microsoft.com/office/drawing/2014/main" id="{19590D87-8FA0-44D6-865D-D5929558BA84}"/>
              </a:ext>
            </a:extLst>
          </p:cNvPr>
          <p:cNvSpPr txBox="1"/>
          <p:nvPr/>
        </p:nvSpPr>
        <p:spPr>
          <a:xfrm>
            <a:off x="9723806" y="2920132"/>
            <a:ext cx="4916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PsaD</a:t>
            </a:r>
          </a:p>
        </p:txBody>
      </p:sp>
      <p:pic>
        <p:nvPicPr>
          <p:cNvPr id="41" name="Picture 40" descr="A picture containing bird&#10;&#10;Description automatically generated">
            <a:extLst>
              <a:ext uri="{FF2B5EF4-FFF2-40B4-BE49-F238E27FC236}">
                <a16:creationId xmlns:a16="http://schemas.microsoft.com/office/drawing/2014/main" id="{9823EC5C-3E3E-4FC1-B0C5-5D7EA09CF9A7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126" t="48328" r="39039" b="47267"/>
          <a:stretch/>
        </p:blipFill>
        <p:spPr>
          <a:xfrm>
            <a:off x="6269976" y="3183457"/>
            <a:ext cx="2040294" cy="345949"/>
          </a:xfrm>
          <a:prstGeom prst="rect">
            <a:avLst/>
          </a:prstGeom>
          <a:ln>
            <a:solidFill>
              <a:schemeClr val="tx1">
                <a:lumMod val="95000"/>
                <a:lumOff val="5000"/>
              </a:schemeClr>
            </a:solidFill>
          </a:ln>
        </p:spPr>
      </p:pic>
      <p:sp>
        <p:nvSpPr>
          <p:cNvPr id="43" name="TextBox 42">
            <a:extLst>
              <a:ext uri="{FF2B5EF4-FFF2-40B4-BE49-F238E27FC236}">
                <a16:creationId xmlns:a16="http://schemas.microsoft.com/office/drawing/2014/main" id="{E53A82DA-5A2A-4111-A654-7AC576322A07}"/>
              </a:ext>
            </a:extLst>
          </p:cNvPr>
          <p:cNvSpPr txBox="1"/>
          <p:nvPr/>
        </p:nvSpPr>
        <p:spPr>
          <a:xfrm>
            <a:off x="7086784" y="2936907"/>
            <a:ext cx="4980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PsbD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CA4C15C9-01B7-45A7-98EE-3406C3B54E2C}"/>
              </a:ext>
            </a:extLst>
          </p:cNvPr>
          <p:cNvSpPr txBox="1"/>
          <p:nvPr/>
        </p:nvSpPr>
        <p:spPr>
          <a:xfrm>
            <a:off x="109650" y="3744205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15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C61BCB82-535C-40AF-8B9A-CF0AB2473C09}"/>
              </a:ext>
            </a:extLst>
          </p:cNvPr>
          <p:cNvSpPr txBox="1"/>
          <p:nvPr/>
        </p:nvSpPr>
        <p:spPr>
          <a:xfrm>
            <a:off x="109650" y="3529406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25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1C374F8B-7761-4DBC-B43B-5462203E332E}"/>
              </a:ext>
            </a:extLst>
          </p:cNvPr>
          <p:cNvSpPr txBox="1"/>
          <p:nvPr/>
        </p:nvSpPr>
        <p:spPr>
          <a:xfrm>
            <a:off x="115870" y="2997893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35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EDBA8DAC-9CFD-4380-BDE9-81831EC91E4E}"/>
              </a:ext>
            </a:extLst>
          </p:cNvPr>
          <p:cNvSpPr txBox="1"/>
          <p:nvPr/>
        </p:nvSpPr>
        <p:spPr>
          <a:xfrm>
            <a:off x="109650" y="2685739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42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ACE65BF4-9F07-4BEE-A756-54FDE533B36C}"/>
              </a:ext>
            </a:extLst>
          </p:cNvPr>
          <p:cNvSpPr txBox="1"/>
          <p:nvPr/>
        </p:nvSpPr>
        <p:spPr>
          <a:xfrm>
            <a:off x="109650" y="2361145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55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6F452860-4755-4A1A-ADA1-5053CA2F4AD6}"/>
              </a:ext>
            </a:extLst>
          </p:cNvPr>
          <p:cNvSpPr txBox="1"/>
          <p:nvPr/>
        </p:nvSpPr>
        <p:spPr>
          <a:xfrm>
            <a:off x="109650" y="2207329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70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E9EE8271-F5A1-48CE-B028-FAF93C8E6DAC}"/>
              </a:ext>
            </a:extLst>
          </p:cNvPr>
          <p:cNvSpPr txBox="1"/>
          <p:nvPr/>
        </p:nvSpPr>
        <p:spPr>
          <a:xfrm>
            <a:off x="31102" y="2055908"/>
            <a:ext cx="4587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120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ACCBB6BA-A9CB-4380-89A9-7DCB66CD0144}"/>
              </a:ext>
            </a:extLst>
          </p:cNvPr>
          <p:cNvSpPr txBox="1"/>
          <p:nvPr/>
        </p:nvSpPr>
        <p:spPr>
          <a:xfrm>
            <a:off x="31102" y="1934986"/>
            <a:ext cx="4587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180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1340805E-3614-4066-82D3-72C51DCBA426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0845" t="46765" r="43123" b="45971"/>
          <a:stretch/>
        </p:blipFill>
        <p:spPr>
          <a:xfrm>
            <a:off x="6269975" y="1339398"/>
            <a:ext cx="2040292" cy="36046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E353C799-B673-4A3B-B2F6-04D6FDCD80A0}"/>
              </a:ext>
            </a:extLst>
          </p:cNvPr>
          <p:cNvSpPr txBox="1"/>
          <p:nvPr/>
        </p:nvSpPr>
        <p:spPr>
          <a:xfrm rot="16200000">
            <a:off x="6185676" y="1796495"/>
            <a:ext cx="5581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25% 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701E0CF-E9A4-4AFD-9C55-C1C9ADA0AD32}"/>
              </a:ext>
            </a:extLst>
          </p:cNvPr>
          <p:cNvSpPr txBox="1"/>
          <p:nvPr/>
        </p:nvSpPr>
        <p:spPr>
          <a:xfrm rot="16200000">
            <a:off x="6471217" y="1796495"/>
            <a:ext cx="5581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50% 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DA6239A-8564-4FAC-A87D-33A98329D137}"/>
              </a:ext>
            </a:extLst>
          </p:cNvPr>
          <p:cNvSpPr txBox="1"/>
          <p:nvPr/>
        </p:nvSpPr>
        <p:spPr>
          <a:xfrm rot="16200000">
            <a:off x="6768147" y="1835768"/>
            <a:ext cx="6367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100% S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EEFFC2F-AD93-4A02-A8F5-9958F779B125}"/>
              </a:ext>
            </a:extLst>
          </p:cNvPr>
          <p:cNvSpPr txBox="1"/>
          <p:nvPr/>
        </p:nvSpPr>
        <p:spPr>
          <a:xfrm rot="16200000">
            <a:off x="7031450" y="1927139"/>
            <a:ext cx="8194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100% SQ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86EB2AC-4188-46DB-941F-C1D38C4CA7E0}"/>
              </a:ext>
            </a:extLst>
          </p:cNvPr>
          <p:cNvSpPr txBox="1"/>
          <p:nvPr/>
        </p:nvSpPr>
        <p:spPr>
          <a:xfrm rot="16200000">
            <a:off x="7450931" y="1872701"/>
            <a:ext cx="7105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100% ES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3F61F7D-D72D-4EE4-ACB1-B57FCD4291C0}"/>
              </a:ext>
            </a:extLst>
          </p:cNvPr>
          <p:cNvSpPr txBox="1"/>
          <p:nvPr/>
        </p:nvSpPr>
        <p:spPr>
          <a:xfrm rot="16200000">
            <a:off x="7815884" y="1879851"/>
            <a:ext cx="7248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100% ER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701D921-A491-4941-BA39-3201AD689907}"/>
              </a:ext>
            </a:extLst>
          </p:cNvPr>
          <p:cNvSpPr txBox="1"/>
          <p:nvPr/>
        </p:nvSpPr>
        <p:spPr>
          <a:xfrm rot="16200000">
            <a:off x="6176665" y="4411741"/>
            <a:ext cx="5581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25% S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9D9A927-7C46-4136-AA66-41F245EB20B7}"/>
              </a:ext>
            </a:extLst>
          </p:cNvPr>
          <p:cNvSpPr txBox="1"/>
          <p:nvPr/>
        </p:nvSpPr>
        <p:spPr>
          <a:xfrm rot="16200000">
            <a:off x="6462206" y="4411741"/>
            <a:ext cx="5581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50% S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568FF7A0-EDB2-4DA1-B23B-87BD9349F636}"/>
              </a:ext>
            </a:extLst>
          </p:cNvPr>
          <p:cNvSpPr txBox="1"/>
          <p:nvPr/>
        </p:nvSpPr>
        <p:spPr>
          <a:xfrm rot="16200000">
            <a:off x="6759136" y="4451014"/>
            <a:ext cx="6367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100% S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4C49CB6-268F-40B6-9266-16C3A3BAF6C6}"/>
              </a:ext>
            </a:extLst>
          </p:cNvPr>
          <p:cNvSpPr txBox="1"/>
          <p:nvPr/>
        </p:nvSpPr>
        <p:spPr>
          <a:xfrm rot="16200000">
            <a:off x="6969815" y="4542385"/>
            <a:ext cx="8194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100% SQ1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39A21D8-769B-4E1C-A2F7-B29B23B52E77}"/>
              </a:ext>
            </a:extLst>
          </p:cNvPr>
          <p:cNvSpPr txBox="1"/>
          <p:nvPr/>
        </p:nvSpPr>
        <p:spPr>
          <a:xfrm rot="16200000">
            <a:off x="7409030" y="4487947"/>
            <a:ext cx="7105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100% ES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0CBF934-362D-4CE1-80C0-2917E7C122C4}"/>
              </a:ext>
            </a:extLst>
          </p:cNvPr>
          <p:cNvSpPr txBox="1"/>
          <p:nvPr/>
        </p:nvSpPr>
        <p:spPr>
          <a:xfrm rot="16200000">
            <a:off x="7734511" y="4495097"/>
            <a:ext cx="7248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100% ER</a:t>
            </a:r>
          </a:p>
        </p:txBody>
      </p:sp>
      <p:pic>
        <p:nvPicPr>
          <p:cNvPr id="58" name="Picture 57">
            <a:extLst>
              <a:ext uri="{FF2B5EF4-FFF2-40B4-BE49-F238E27FC236}">
                <a16:creationId xmlns:a16="http://schemas.microsoft.com/office/drawing/2014/main" id="{49DE6E8D-6B87-4A26-908B-837BCFCB7BFA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915" t="44194" r="45023" b="49999"/>
          <a:stretch/>
        </p:blipFill>
        <p:spPr>
          <a:xfrm>
            <a:off x="8815740" y="957329"/>
            <a:ext cx="2038648" cy="34594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1" name="TextBox 60">
            <a:extLst>
              <a:ext uri="{FF2B5EF4-FFF2-40B4-BE49-F238E27FC236}">
                <a16:creationId xmlns:a16="http://schemas.microsoft.com/office/drawing/2014/main" id="{5EB9A19F-4BC0-4ED9-AB81-E5748C505CB0}"/>
              </a:ext>
            </a:extLst>
          </p:cNvPr>
          <p:cNvSpPr txBox="1"/>
          <p:nvPr/>
        </p:nvSpPr>
        <p:spPr>
          <a:xfrm>
            <a:off x="5369950" y="611606"/>
            <a:ext cx="8701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Replicate 1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ECE1F4C8-93EA-42BB-BDB8-E368388BF8A7}"/>
              </a:ext>
            </a:extLst>
          </p:cNvPr>
          <p:cNvSpPr txBox="1"/>
          <p:nvPr/>
        </p:nvSpPr>
        <p:spPr>
          <a:xfrm>
            <a:off x="5366213" y="1006682"/>
            <a:ext cx="8701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Replicate 2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EA4C17A2-BAA6-40F2-BF6E-024F06CEC789}"/>
              </a:ext>
            </a:extLst>
          </p:cNvPr>
          <p:cNvSpPr txBox="1"/>
          <p:nvPr/>
        </p:nvSpPr>
        <p:spPr>
          <a:xfrm>
            <a:off x="5361028" y="1408347"/>
            <a:ext cx="8701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Replicate 3</a:t>
            </a:r>
          </a:p>
        </p:txBody>
      </p:sp>
      <p:pic>
        <p:nvPicPr>
          <p:cNvPr id="67" name="Picture 66">
            <a:extLst>
              <a:ext uri="{FF2B5EF4-FFF2-40B4-BE49-F238E27FC236}">
                <a16:creationId xmlns:a16="http://schemas.microsoft.com/office/drawing/2014/main" id="{AFF2DC13-3341-48AF-AD70-75F078BE2EC8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359" t="47816" r="40916" b="47816"/>
          <a:stretch/>
        </p:blipFill>
        <p:spPr>
          <a:xfrm>
            <a:off x="8811312" y="1339397"/>
            <a:ext cx="2043076" cy="34594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9" name="TextBox 68">
            <a:extLst>
              <a:ext uri="{FF2B5EF4-FFF2-40B4-BE49-F238E27FC236}">
                <a16:creationId xmlns:a16="http://schemas.microsoft.com/office/drawing/2014/main" id="{1086B80E-9CA1-433F-9B22-D8FAAB177EC7}"/>
              </a:ext>
            </a:extLst>
          </p:cNvPr>
          <p:cNvSpPr txBox="1"/>
          <p:nvPr/>
        </p:nvSpPr>
        <p:spPr>
          <a:xfrm rot="16200000">
            <a:off x="8668881" y="1788228"/>
            <a:ext cx="5581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25% S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2689D4F7-C5CE-4763-A50E-A5B8877166B7}"/>
              </a:ext>
            </a:extLst>
          </p:cNvPr>
          <p:cNvSpPr txBox="1"/>
          <p:nvPr/>
        </p:nvSpPr>
        <p:spPr>
          <a:xfrm rot="16200000">
            <a:off x="8954422" y="1788228"/>
            <a:ext cx="5581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50% S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CC2C097A-C412-4C7A-B263-4EF9E358AF6A}"/>
              </a:ext>
            </a:extLst>
          </p:cNvPr>
          <p:cNvSpPr txBox="1"/>
          <p:nvPr/>
        </p:nvSpPr>
        <p:spPr>
          <a:xfrm rot="16200000">
            <a:off x="9251352" y="1827501"/>
            <a:ext cx="6367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100% S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385074AC-7E70-43A3-84F2-CFA91280D6E4}"/>
              </a:ext>
            </a:extLst>
          </p:cNvPr>
          <p:cNvSpPr txBox="1"/>
          <p:nvPr/>
        </p:nvSpPr>
        <p:spPr>
          <a:xfrm rot="16200000">
            <a:off x="9514655" y="1918872"/>
            <a:ext cx="8194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100% SQ1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F8153E6C-D141-42F6-AD72-9F11A1FF0976}"/>
              </a:ext>
            </a:extLst>
          </p:cNvPr>
          <p:cNvSpPr txBox="1"/>
          <p:nvPr/>
        </p:nvSpPr>
        <p:spPr>
          <a:xfrm rot="16200000">
            <a:off x="9934136" y="1864434"/>
            <a:ext cx="7105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100% ES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0A347D3C-002A-45D5-B4A2-5789B472AFC2}"/>
              </a:ext>
            </a:extLst>
          </p:cNvPr>
          <p:cNvSpPr txBox="1"/>
          <p:nvPr/>
        </p:nvSpPr>
        <p:spPr>
          <a:xfrm rot="16200000">
            <a:off x="10299089" y="1871584"/>
            <a:ext cx="7248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100% ER</a:t>
            </a:r>
          </a:p>
        </p:txBody>
      </p:sp>
      <p:pic>
        <p:nvPicPr>
          <p:cNvPr id="81" name="Picture 80" descr="A picture containing screenshot&#10;&#10;Description automatically generated">
            <a:extLst>
              <a:ext uri="{FF2B5EF4-FFF2-40B4-BE49-F238E27FC236}">
                <a16:creationId xmlns:a16="http://schemas.microsoft.com/office/drawing/2014/main" id="{C369778F-A630-4849-88CB-E79CA02681CC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844" t="43180" r="37229" b="49556"/>
          <a:stretch/>
        </p:blipFill>
        <p:spPr>
          <a:xfrm>
            <a:off x="6269974" y="3566762"/>
            <a:ext cx="2040291" cy="34594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3" name="Picture 82">
            <a:extLst>
              <a:ext uri="{FF2B5EF4-FFF2-40B4-BE49-F238E27FC236}">
                <a16:creationId xmlns:a16="http://schemas.microsoft.com/office/drawing/2014/main" id="{BF620F5B-1CB8-4229-B0D5-50E150B32655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7038" t="48079" r="47332" b="44658"/>
          <a:stretch/>
        </p:blipFill>
        <p:spPr>
          <a:xfrm>
            <a:off x="6269973" y="3956645"/>
            <a:ext cx="2046849" cy="34594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5" name="TextBox 84">
            <a:extLst>
              <a:ext uri="{FF2B5EF4-FFF2-40B4-BE49-F238E27FC236}">
                <a16:creationId xmlns:a16="http://schemas.microsoft.com/office/drawing/2014/main" id="{D40F5A24-C6A5-4088-9AAB-3F76DF359AAF}"/>
              </a:ext>
            </a:extLst>
          </p:cNvPr>
          <p:cNvSpPr txBox="1"/>
          <p:nvPr/>
        </p:nvSpPr>
        <p:spPr>
          <a:xfrm>
            <a:off x="5456060" y="3188429"/>
            <a:ext cx="8701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Replicate 1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A6062525-8566-42CD-9274-67342FD6929D}"/>
              </a:ext>
            </a:extLst>
          </p:cNvPr>
          <p:cNvSpPr txBox="1"/>
          <p:nvPr/>
        </p:nvSpPr>
        <p:spPr>
          <a:xfrm>
            <a:off x="5452323" y="3583505"/>
            <a:ext cx="8701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Replicate 2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C5B89DDE-9AD9-4879-A128-7B71901ECAE1}"/>
              </a:ext>
            </a:extLst>
          </p:cNvPr>
          <p:cNvSpPr txBox="1"/>
          <p:nvPr/>
        </p:nvSpPr>
        <p:spPr>
          <a:xfrm>
            <a:off x="5447138" y="3985170"/>
            <a:ext cx="8701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Replicate 3</a:t>
            </a:r>
          </a:p>
        </p:txBody>
      </p:sp>
      <p:pic>
        <p:nvPicPr>
          <p:cNvPr id="91" name="Picture 90" descr="A picture containing text, electronics, projector&#10;&#10;Description automatically generated">
            <a:extLst>
              <a:ext uri="{FF2B5EF4-FFF2-40B4-BE49-F238E27FC236}">
                <a16:creationId xmlns:a16="http://schemas.microsoft.com/office/drawing/2014/main" id="{CE33B8CB-8A29-46FF-9B90-86F91CAE4530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7397" t="62513" r="47332" b="31928"/>
          <a:stretch/>
        </p:blipFill>
        <p:spPr>
          <a:xfrm>
            <a:off x="8844380" y="3577315"/>
            <a:ext cx="2046848" cy="32881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5" name="Picture 94">
            <a:extLst>
              <a:ext uri="{FF2B5EF4-FFF2-40B4-BE49-F238E27FC236}">
                <a16:creationId xmlns:a16="http://schemas.microsoft.com/office/drawing/2014/main" id="{D5EB2EF5-A9A3-487A-8AE6-6CC93EC0AA87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5667" t="59099" r="38703" b="35954"/>
          <a:stretch/>
        </p:blipFill>
        <p:spPr>
          <a:xfrm>
            <a:off x="8846363" y="3944183"/>
            <a:ext cx="2053868" cy="34594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7" name="TextBox 96">
            <a:extLst>
              <a:ext uri="{FF2B5EF4-FFF2-40B4-BE49-F238E27FC236}">
                <a16:creationId xmlns:a16="http://schemas.microsoft.com/office/drawing/2014/main" id="{EA319160-8442-4221-AD63-2B33115FBCEC}"/>
              </a:ext>
            </a:extLst>
          </p:cNvPr>
          <p:cNvSpPr txBox="1"/>
          <p:nvPr/>
        </p:nvSpPr>
        <p:spPr>
          <a:xfrm rot="16200000">
            <a:off x="8734896" y="4409435"/>
            <a:ext cx="5581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25% S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ECE82A51-7653-4B00-AF70-2426EE934B94}"/>
              </a:ext>
            </a:extLst>
          </p:cNvPr>
          <p:cNvSpPr txBox="1"/>
          <p:nvPr/>
        </p:nvSpPr>
        <p:spPr>
          <a:xfrm rot="16200000">
            <a:off x="9020437" y="4409435"/>
            <a:ext cx="5581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50% S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AB555F82-4615-455D-9DFF-D7913E6EE003}"/>
              </a:ext>
            </a:extLst>
          </p:cNvPr>
          <p:cNvSpPr txBox="1"/>
          <p:nvPr/>
        </p:nvSpPr>
        <p:spPr>
          <a:xfrm rot="16200000">
            <a:off x="9317367" y="4448708"/>
            <a:ext cx="6367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100% S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7557A765-0278-4E51-B287-E53CAA697D5B}"/>
              </a:ext>
            </a:extLst>
          </p:cNvPr>
          <p:cNvSpPr txBox="1"/>
          <p:nvPr/>
        </p:nvSpPr>
        <p:spPr>
          <a:xfrm rot="16200000">
            <a:off x="9528046" y="4540079"/>
            <a:ext cx="8194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100% SQ1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7F19828B-A5AC-4B84-8E29-396F85D5EED8}"/>
              </a:ext>
            </a:extLst>
          </p:cNvPr>
          <p:cNvSpPr txBox="1"/>
          <p:nvPr/>
        </p:nvSpPr>
        <p:spPr>
          <a:xfrm rot="16200000">
            <a:off x="9967261" y="4485641"/>
            <a:ext cx="7105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100% ES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6AB4E36A-4ECA-4F42-BB0A-8C5A2575D12F}"/>
              </a:ext>
            </a:extLst>
          </p:cNvPr>
          <p:cNvSpPr txBox="1"/>
          <p:nvPr/>
        </p:nvSpPr>
        <p:spPr>
          <a:xfrm rot="16200000">
            <a:off x="10292742" y="4492791"/>
            <a:ext cx="7248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100% ER</a:t>
            </a:r>
          </a:p>
        </p:txBody>
      </p:sp>
      <p:pic>
        <p:nvPicPr>
          <p:cNvPr id="109" name="Picture 108">
            <a:extLst>
              <a:ext uri="{FF2B5EF4-FFF2-40B4-BE49-F238E27FC236}">
                <a16:creationId xmlns:a16="http://schemas.microsoft.com/office/drawing/2014/main" id="{9014A521-0948-4A28-8F01-338AEF56FDB4}"/>
              </a:ext>
            </a:extLst>
          </p:cNvPr>
          <p:cNvPicPr>
            <a:picLocks noChangeAspect="1"/>
          </p:cNvPicPr>
          <p:nvPr/>
        </p:nvPicPr>
        <p:blipFill rotWithShape="1">
          <a:blip r:embed="rId20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7644" t="51630" r="46234" b="39239"/>
          <a:stretch/>
        </p:blipFill>
        <p:spPr>
          <a:xfrm>
            <a:off x="6273274" y="961025"/>
            <a:ext cx="2043547" cy="341017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2446573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4</TotalTime>
  <Words>151</Words>
  <Application>Microsoft Office PowerPoint</Application>
  <PresentationFormat>Widescreen</PresentationFormat>
  <Paragraphs>5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ushan Bag</dc:creator>
  <cp:lastModifiedBy>Pushan Bag</cp:lastModifiedBy>
  <cp:revision>13</cp:revision>
  <dcterms:created xsi:type="dcterms:W3CDTF">2020-10-28T13:49:36Z</dcterms:created>
  <dcterms:modified xsi:type="dcterms:W3CDTF">2020-11-04T12:44:03Z</dcterms:modified>
</cp:coreProperties>
</file>